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81" r:id="rId2"/>
    <p:sldId id="275" r:id="rId3"/>
    <p:sldId id="271" r:id="rId4"/>
    <p:sldId id="272" r:id="rId5"/>
    <p:sldId id="282" r:id="rId6"/>
    <p:sldId id="279" r:id="rId7"/>
    <p:sldId id="277" r:id="rId8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7989" autoAdjust="0"/>
    <p:restoredTop sz="94660"/>
  </p:normalViewPr>
  <p:slideViewPr>
    <p:cSldViewPr snapToGrid="0">
      <p:cViewPr varScale="1">
        <p:scale>
          <a:sx n="64" d="100"/>
          <a:sy n="64" d="100"/>
        </p:scale>
        <p:origin x="636" y="3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B2B509-0973-4396-B19B-4C34FECF5EC9}" type="datetimeFigureOut">
              <a:rPr lang="en-US" smtClean="0"/>
              <a:t>7/2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8B5AD5-B68A-4738-869B-EDEA9210CE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2540758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B2B509-0973-4396-B19B-4C34FECF5EC9}" type="datetimeFigureOut">
              <a:rPr lang="en-US" smtClean="0"/>
              <a:t>7/2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8B5AD5-B68A-4738-869B-EDEA9210CE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4006505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B2B509-0973-4396-B19B-4C34FECF5EC9}" type="datetimeFigureOut">
              <a:rPr lang="en-US" smtClean="0"/>
              <a:t>7/2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8B5AD5-B68A-4738-869B-EDEA9210CE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061861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B2B509-0973-4396-B19B-4C34FECF5EC9}" type="datetimeFigureOut">
              <a:rPr lang="en-US" smtClean="0"/>
              <a:t>7/2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8B5AD5-B68A-4738-869B-EDEA9210CE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8144146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B2B509-0973-4396-B19B-4C34FECF5EC9}" type="datetimeFigureOut">
              <a:rPr lang="en-US" smtClean="0"/>
              <a:t>7/2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8B5AD5-B68A-4738-869B-EDEA9210CE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067416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B2B509-0973-4396-B19B-4C34FECF5EC9}" type="datetimeFigureOut">
              <a:rPr lang="en-US" smtClean="0"/>
              <a:t>7/20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8B5AD5-B68A-4738-869B-EDEA9210CE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2922467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B2B509-0973-4396-B19B-4C34FECF5EC9}" type="datetimeFigureOut">
              <a:rPr lang="en-US" smtClean="0"/>
              <a:t>7/20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8B5AD5-B68A-4738-869B-EDEA9210CE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6992846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B2B509-0973-4396-B19B-4C34FECF5EC9}" type="datetimeFigureOut">
              <a:rPr lang="en-US" smtClean="0"/>
              <a:t>7/20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8B5AD5-B68A-4738-869B-EDEA9210CE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654215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B2B509-0973-4396-B19B-4C34FECF5EC9}" type="datetimeFigureOut">
              <a:rPr lang="en-US" smtClean="0"/>
              <a:t>7/20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8B5AD5-B68A-4738-869B-EDEA9210CE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6011185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B2B509-0973-4396-B19B-4C34FECF5EC9}" type="datetimeFigureOut">
              <a:rPr lang="en-US" smtClean="0"/>
              <a:t>7/20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8B5AD5-B68A-4738-869B-EDEA9210CE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321151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B2B509-0973-4396-B19B-4C34FECF5EC9}" type="datetimeFigureOut">
              <a:rPr lang="en-US" smtClean="0"/>
              <a:t>7/20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8B5AD5-B68A-4738-869B-EDEA9210CE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3124653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BB2B509-0973-4396-B19B-4C34FECF5EC9}" type="datetimeFigureOut">
              <a:rPr lang="en-US" smtClean="0"/>
              <a:t>7/2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38B5AD5-B68A-4738-869B-EDEA9210CE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5710431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2337078" y="4416556"/>
            <a:ext cx="7917968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 The auto-oxidation of L-DOPA (2 mg/mL) occurred spontaneously in both control M9 and LB media after an overnight incubation at 37°C, 200 rpm (top).  However, evidence of L-DOPA auto-oxidation was not apparent in M9 medium when cultured with </a:t>
            </a:r>
            <a:r>
              <a:rPr lang="en-US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. coli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BL21 (DE3) cells expressing the </a:t>
            </a:r>
            <a:r>
              <a:rPr lang="en-US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paBC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enzyme (bottom).  Conversely, L-DOPA auto-oxidation was still evident in LB medium when cultured with </a:t>
            </a:r>
            <a:r>
              <a:rPr lang="en-US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. coli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777090" y="551010"/>
            <a:ext cx="5261304" cy="358475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03614491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Picture 7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635849" y="617089"/>
            <a:ext cx="8303472" cy="4334632"/>
          </a:xfrm>
          <a:prstGeom prst="rect">
            <a:avLst/>
          </a:prstGeom>
        </p:spPr>
      </p:pic>
      <p:sp>
        <p:nvSpPr>
          <p:cNvPr id="7" name="TextBox 6"/>
          <p:cNvSpPr txBox="1"/>
          <p:nvPr/>
        </p:nvSpPr>
        <p:spPr>
          <a:xfrm>
            <a:off x="1537527" y="5044908"/>
            <a:ext cx="7510441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S2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ptical density readings (OD</a:t>
            </a:r>
            <a:r>
              <a:rPr lang="en-US" sz="12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600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of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ecombinantly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expressed </a:t>
            </a:r>
            <a:r>
              <a:rPr lang="en-US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elA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. coli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 Cultures were grown in M9 (blue traces) or LB (black traces) media and </a:t>
            </a:r>
            <a:r>
              <a:rPr lang="en-US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elA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as expressed constitutively from the pCB1D5 plasmid (dashed lines) or induced by 1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M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PTG using the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JV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lasmid (solid lines).  Measurements were taken from control cultures not supplemented with tyrosine.  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Melanin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oduction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 </a:t>
            </a:r>
            <a:r>
              <a:rPr lang="en-US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. coli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xpressing </a:t>
            </a:r>
            <a:r>
              <a:rPr lang="en-US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elA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by measuring absorbance values at 492 nm of culture-free supernatants over the course of 6 days. 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C)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elA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protein expression analysis (predicted MW ~55 </a:t>
            </a:r>
            <a:r>
              <a:rPr lang="en-US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 from </a:t>
            </a:r>
            <a:r>
              <a:rPr lang="en-US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V. natriegens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oluble cell extracts as visualized by SDS-PAGE and </a:t>
            </a:r>
            <a:r>
              <a:rPr lang="en-US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oomassie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staining. 20 </a:t>
            </a:r>
            <a:r>
              <a:rPr lang="en-US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ug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total protein loaded in each lane.  Values above each lane represent time post-induction.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TextBox 1"/>
          <p:cNvSpPr txBox="1"/>
          <p:nvPr/>
        </p:nvSpPr>
        <p:spPr>
          <a:xfrm>
            <a:off x="1361838" y="453195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5540940" y="451959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1361838" y="3006579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7291603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1286458" y="4747764"/>
            <a:ext cx="9130887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S3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Representative growth curves of </a:t>
            </a:r>
            <a:r>
              <a:rPr lang="en-US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V. </a:t>
            </a:r>
            <a:r>
              <a:rPr lang="en-US" sz="1200" i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atriegens</a:t>
            </a:r>
            <a:r>
              <a:rPr lang="en-US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hen screening conditions for the development of VnM9v2 medium using the </a:t>
            </a:r>
            <a:r>
              <a:rPr lang="en-US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ioscreen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C.  Effects of 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phosphate, 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sodium chloride, 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C)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carbon source, 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D)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aspartate, and 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E)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etals concentrations have on </a:t>
            </a:r>
            <a:r>
              <a:rPr lang="en-US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V. </a:t>
            </a:r>
            <a:r>
              <a:rPr lang="en-US" sz="1200" i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atriegens</a:t>
            </a:r>
            <a:r>
              <a:rPr lang="en-US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rowth (optical density) or final media pH, as indicated.  For testing of carbon sources, all concentrations were kept consistent at 20 </a:t>
            </a:r>
            <a:r>
              <a:rPr lang="en-US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M.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All traces are averages of biological triplicates.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97998" y="847770"/>
            <a:ext cx="9132600" cy="3785944"/>
          </a:xfrm>
          <a:prstGeom prst="rect">
            <a:avLst/>
          </a:prstGeom>
        </p:spPr>
      </p:pic>
      <p:sp>
        <p:nvSpPr>
          <p:cNvPr id="7" name="TextBox 6"/>
          <p:cNvSpPr txBox="1"/>
          <p:nvPr/>
        </p:nvSpPr>
        <p:spPr>
          <a:xfrm>
            <a:off x="1286458" y="549054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4044406" y="549054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6989167" y="549054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1286458" y="2591384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endParaRPr 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4044406" y="2591384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</a:t>
            </a:r>
            <a:endParaRPr 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8661332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92AEE366-5E22-44C7-8924-81983C9B537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99409" y="1696326"/>
            <a:ext cx="6792068" cy="2293828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246956" y="1878407"/>
            <a:ext cx="2162945" cy="2232437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1299410" y="4261153"/>
            <a:ext cx="911049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S4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Schematic of acid/base cycling procedure used for the purification of melanin from </a:t>
            </a:r>
            <a:r>
              <a:rPr lang="en-US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V. </a:t>
            </a:r>
            <a:r>
              <a:rPr lang="en-US" sz="1200" i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atriegens</a:t>
            </a:r>
            <a:r>
              <a:rPr lang="en-US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ultures.  The final purified, dried melanin product is pictured on the right.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2562824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985545" y="1431236"/>
            <a:ext cx="5907797" cy="3338207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2985544" y="4769443"/>
            <a:ext cx="5907797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S5.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FU/mL measurements of melanin toxicity induced after a 2 hour incubation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o </a:t>
            </a:r>
            <a:r>
              <a:rPr lang="en-US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V. natriegens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r </a:t>
            </a:r>
            <a:r>
              <a:rPr lang="en-US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. coli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L21(DE3) cells during mid-log phase growth.  Media was pre-incubation with the indicated concentration of melanin for 3 hours. Error bars represent the standard deviation of 3 biological replicates.  Differences in CFUs between melanin concentrations tested were determined to be non-significant (p </a:t>
            </a:r>
            <a:r>
              <a:rPr lang="en-US" sz="1200" u="sng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&gt;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0.05) by student’s t-test.</a:t>
            </a:r>
            <a:endParaRPr 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86371919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2418165" y="5010301"/>
            <a:ext cx="604166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S6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Representative traces of </a:t>
            </a:r>
            <a:r>
              <a:rPr lang="en-US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V. natriegens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rowth in bioreactors.  Media pH (dashed traces) and optical density (solid traces) were monitored for the low phosphate (20 </a:t>
            </a:r>
            <a:r>
              <a:rPr lang="en-US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M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 variation (blue), the Na</a:t>
            </a:r>
            <a:r>
              <a:rPr lang="en-US" sz="1200" baseline="-25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O</a:t>
            </a:r>
            <a:r>
              <a:rPr lang="en-US" sz="1200" baseline="-25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substituted variation (red), and standard VnM9v2 (black) media.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1" name="Picture 10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418165" y="590318"/>
            <a:ext cx="6041660" cy="441998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46816156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/>
          <p:cNvSpPr txBox="1"/>
          <p:nvPr/>
        </p:nvSpPr>
        <p:spPr>
          <a:xfrm>
            <a:off x="2733418" y="4261153"/>
            <a:ext cx="5151036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S7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qRT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PCR analysis of putative copper responsive genes involved in the copper stress response in </a:t>
            </a:r>
            <a:r>
              <a:rPr lang="en-US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V. natriegens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dentified by bioinformatics and manual curation of the genome.  Transcript abundances were normalized to the housekeeping gene </a:t>
            </a:r>
            <a:r>
              <a:rPr lang="en-US" sz="1200" i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apA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 Fold changes calculated by the </a:t>
            </a:r>
            <a:r>
              <a:rPr lang="el-GR" sz="1200" dirty="0" smtClean="0">
                <a:latin typeface="Calibri" panose="020F0502020204030204" pitchFamily="34" charset="0"/>
                <a:cs typeface="Calibri" panose="020F0502020204030204" pitchFamily="34" charset="0"/>
              </a:rPr>
              <a:t>ΔΔ</a:t>
            </a:r>
            <a:r>
              <a:rPr lang="en-US" sz="1200" dirty="0" smtClean="0">
                <a:latin typeface="Calibri" panose="020F0502020204030204" pitchFamily="34" charset="0"/>
                <a:cs typeface="Calibri" panose="020F0502020204030204" pitchFamily="34" charset="0"/>
              </a:rPr>
              <a:t>C</a:t>
            </a:r>
            <a:r>
              <a:rPr lang="en-US" sz="1200" baseline="-25000" dirty="0" smtClean="0">
                <a:latin typeface="Calibri" panose="020F0502020204030204" pitchFamily="34" charset="0"/>
                <a:cs typeface="Calibri" panose="020F0502020204030204" pitchFamily="34" charset="0"/>
              </a:rPr>
              <a:t>T</a:t>
            </a:r>
            <a:r>
              <a:rPr lang="en-US" sz="1200" dirty="0" smtClean="0">
                <a:latin typeface="Calibri" panose="020F0502020204030204" pitchFamily="34" charset="0"/>
                <a:cs typeface="Calibri" panose="020F0502020204030204" pitchFamily="34" charset="0"/>
              </a:rPr>
              <a:t> method. 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rror bars represent standard deviations of the mean.  *p &lt; 0.05, **p &lt; 0.01, *** p &lt; 0.005.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733418" y="975124"/>
            <a:ext cx="5151566" cy="328602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1863336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483</TotalTime>
  <Words>567</Words>
  <Application>Microsoft Office PowerPoint</Application>
  <PresentationFormat>Widescreen</PresentationFormat>
  <Paragraphs>15</Paragraphs>
  <Slides>7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12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Department of Defense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aron Smith, Contractor, Code 6910</dc:creator>
  <cp:lastModifiedBy>Aaron Smith, Contractor, Code 6910</cp:lastModifiedBy>
  <cp:revision>65</cp:revision>
  <cp:lastPrinted>2023-04-13T19:34:17Z</cp:lastPrinted>
  <dcterms:created xsi:type="dcterms:W3CDTF">2023-03-28T16:36:15Z</dcterms:created>
  <dcterms:modified xsi:type="dcterms:W3CDTF">2023-07-20T18:21:31Z</dcterms:modified>
</cp:coreProperties>
</file>